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19" r:id="rId2"/>
  </p:sldIdLst>
  <p:sldSz cx="7200900" cy="9144000"/>
  <p:notesSz cx="6797675" cy="9928225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90" userDrawn="1">
          <p15:clr>
            <a:srgbClr val="A4A3A4"/>
          </p15:clr>
        </p15:guide>
        <p15:guide id="2" pos="29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CC00"/>
    <a:srgbClr val="FF9900"/>
    <a:srgbClr val="5B9BD5"/>
    <a:srgbClr val="FF6703"/>
    <a:srgbClr val="8ACCFF"/>
    <a:srgbClr val="B5E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725" autoAdjust="0"/>
    <p:restoredTop sz="99482" autoAdjust="0"/>
  </p:normalViewPr>
  <p:slideViewPr>
    <p:cSldViewPr snapToGrid="0">
      <p:cViewPr>
        <p:scale>
          <a:sx n="125" d="100"/>
          <a:sy n="125" d="100"/>
        </p:scale>
        <p:origin x="912" y="848"/>
      </p:cViewPr>
      <p:guideLst>
        <p:guide orient="horz" pos="2290"/>
        <p:guide pos="299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90012" cy="90012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ewme/Documents/Ewa/manuscripts%20current/dFC2-aspen/data/Xylan%20acetylation_MADLI_DFC2%20heat%20treat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lative '!$W$64</c:f>
              <c:strCache>
                <c:ptCount val="1"/>
                <c:pt idx="0">
                  <c:v>WT </c:v>
                </c:pt>
              </c:strCache>
            </c:strRef>
          </c:tx>
          <c:spPr>
            <a:solidFill>
              <a:srgbClr val="5B9BD5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lative '!$X$70:$AC$70</c:f>
                <c:numCache>
                  <c:formatCode>General</c:formatCode>
                  <c:ptCount val="6"/>
                  <c:pt idx="0">
                    <c:v>0.186577618348651</c:v>
                  </c:pt>
                  <c:pt idx="1">
                    <c:v>0.196799052759348</c:v>
                  </c:pt>
                  <c:pt idx="2">
                    <c:v>0.1215226480013</c:v>
                  </c:pt>
                  <c:pt idx="3">
                    <c:v>0.448976804903107</c:v>
                  </c:pt>
                  <c:pt idx="4">
                    <c:v>0.678081750168708</c:v>
                  </c:pt>
                  <c:pt idx="5">
                    <c:v>0.678081750168708</c:v>
                  </c:pt>
                </c:numCache>
              </c:numRef>
            </c:plus>
            <c:minus>
              <c:numRef>
                <c:f>'Relative '!$X$70:$AC$70</c:f>
                <c:numCache>
                  <c:formatCode>General</c:formatCode>
                  <c:ptCount val="6"/>
                  <c:pt idx="0">
                    <c:v>0.186577618348651</c:v>
                  </c:pt>
                  <c:pt idx="1">
                    <c:v>0.196799052759348</c:v>
                  </c:pt>
                  <c:pt idx="2">
                    <c:v>0.1215226480013</c:v>
                  </c:pt>
                  <c:pt idx="3">
                    <c:v>0.448976804903107</c:v>
                  </c:pt>
                  <c:pt idx="4">
                    <c:v>0.678081750168708</c:v>
                  </c:pt>
                  <c:pt idx="5">
                    <c:v>0.678081750168708</c:v>
                  </c:pt>
                </c:numCache>
              </c:numRef>
            </c:minus>
          </c:errBars>
          <c:cat>
            <c:strRef>
              <c:f>'Relative '!$X$63:$AB$63</c:f>
              <c:strCache>
                <c:ptCount val="5"/>
                <c:pt idx="0">
                  <c:v>X3G2</c:v>
                </c:pt>
                <c:pt idx="1">
                  <c:v>X23</c:v>
                </c:pt>
                <c:pt idx="2">
                  <c:v>X3</c:v>
                </c:pt>
                <c:pt idx="3">
                  <c:v>X2</c:v>
                </c:pt>
                <c:pt idx="4">
                  <c:v>Sum Ac</c:v>
                </c:pt>
              </c:strCache>
            </c:strRef>
          </c:cat>
          <c:val>
            <c:numRef>
              <c:f>'Relative '!$X$64:$AB$64</c:f>
              <c:numCache>
                <c:formatCode>General</c:formatCode>
                <c:ptCount val="5"/>
                <c:pt idx="0">
                  <c:v>6.312875606753439</c:v>
                </c:pt>
                <c:pt idx="1">
                  <c:v>3.246611127554962</c:v>
                </c:pt>
                <c:pt idx="2">
                  <c:v>3.015495833104076</c:v>
                </c:pt>
                <c:pt idx="3">
                  <c:v>21.96198238648993</c:v>
                </c:pt>
                <c:pt idx="4">
                  <c:v>34.53696495390226</c:v>
                </c:pt>
              </c:numCache>
            </c:numRef>
          </c:val>
        </c:ser>
        <c:ser>
          <c:idx val="1"/>
          <c:order val="1"/>
          <c:tx>
            <c:strRef>
              <c:f>'Relative '!$W$65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rgbClr val="FF99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lative '!$X$71:$AC$71</c:f>
                <c:numCache>
                  <c:formatCode>General</c:formatCode>
                  <c:ptCount val="6"/>
                  <c:pt idx="0">
                    <c:v>0.372405991876495</c:v>
                  </c:pt>
                  <c:pt idx="1">
                    <c:v>0.177428705112973</c:v>
                  </c:pt>
                  <c:pt idx="2">
                    <c:v>0.0822753826466524</c:v>
                  </c:pt>
                  <c:pt idx="3">
                    <c:v>0.816690456382471</c:v>
                  </c:pt>
                  <c:pt idx="4">
                    <c:v>1.080250588158145</c:v>
                  </c:pt>
                  <c:pt idx="5">
                    <c:v>1.080250588158147</c:v>
                  </c:pt>
                </c:numCache>
              </c:numRef>
            </c:plus>
            <c:minus>
              <c:numRef>
                <c:f>'Relative '!$X$71:$AC$71</c:f>
                <c:numCache>
                  <c:formatCode>General</c:formatCode>
                  <c:ptCount val="6"/>
                  <c:pt idx="0">
                    <c:v>0.372405991876495</c:v>
                  </c:pt>
                  <c:pt idx="1">
                    <c:v>0.177428705112973</c:v>
                  </c:pt>
                  <c:pt idx="2">
                    <c:v>0.0822753826466524</c:v>
                  </c:pt>
                  <c:pt idx="3">
                    <c:v>0.816690456382471</c:v>
                  </c:pt>
                  <c:pt idx="4">
                    <c:v>1.080250588158145</c:v>
                  </c:pt>
                  <c:pt idx="5">
                    <c:v>1.080250588158147</c:v>
                  </c:pt>
                </c:numCache>
              </c:numRef>
            </c:minus>
          </c:errBars>
          <c:cat>
            <c:strRef>
              <c:f>'Relative '!$X$63:$AB$63</c:f>
              <c:strCache>
                <c:ptCount val="5"/>
                <c:pt idx="0">
                  <c:v>X3G2</c:v>
                </c:pt>
                <c:pt idx="1">
                  <c:v>X23</c:v>
                </c:pt>
                <c:pt idx="2">
                  <c:v>X3</c:v>
                </c:pt>
                <c:pt idx="3">
                  <c:v>X2</c:v>
                </c:pt>
                <c:pt idx="4">
                  <c:v>Sum Ac</c:v>
                </c:pt>
              </c:strCache>
            </c:strRef>
          </c:cat>
          <c:val>
            <c:numRef>
              <c:f>'Relative '!$X$65:$AB$65</c:f>
              <c:numCache>
                <c:formatCode>General</c:formatCode>
                <c:ptCount val="5"/>
                <c:pt idx="0">
                  <c:v>6.364949394718645</c:v>
                </c:pt>
                <c:pt idx="1">
                  <c:v>3.137971051922061</c:v>
                </c:pt>
                <c:pt idx="2">
                  <c:v>2.917537786290223</c:v>
                </c:pt>
                <c:pt idx="3">
                  <c:v>18.75471912295404</c:v>
                </c:pt>
                <c:pt idx="4">
                  <c:v>31.17517735588497</c:v>
                </c:pt>
              </c:numCache>
            </c:numRef>
          </c:val>
        </c:ser>
        <c:ser>
          <c:idx val="2"/>
          <c:order val="2"/>
          <c:tx>
            <c:strRef>
              <c:f>'Relative '!$W$66</c:f>
              <c:strCache>
                <c:ptCount val="1"/>
                <c:pt idx="0">
                  <c:v>17</c:v>
                </c:pt>
              </c:strCache>
            </c:strRef>
          </c:tx>
          <c:spPr>
            <a:solidFill>
              <a:srgbClr val="FFCC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Relative '!$X$72:$AC$72</c:f>
                <c:numCache>
                  <c:formatCode>General</c:formatCode>
                  <c:ptCount val="6"/>
                  <c:pt idx="0">
                    <c:v>0.373437960525308</c:v>
                  </c:pt>
                  <c:pt idx="1">
                    <c:v>0.0684203601158958</c:v>
                  </c:pt>
                  <c:pt idx="2">
                    <c:v>0.568626019592589</c:v>
                  </c:pt>
                  <c:pt idx="3">
                    <c:v>0.456032448934144</c:v>
                  </c:pt>
                  <c:pt idx="4">
                    <c:v>0.771093471824483</c:v>
                  </c:pt>
                  <c:pt idx="5">
                    <c:v>0.771093471824486</c:v>
                  </c:pt>
                </c:numCache>
              </c:numRef>
            </c:plus>
            <c:minus>
              <c:numRef>
                <c:f>'Relative '!$X$72:$AC$72</c:f>
                <c:numCache>
                  <c:formatCode>General</c:formatCode>
                  <c:ptCount val="6"/>
                  <c:pt idx="0">
                    <c:v>0.373437960525308</c:v>
                  </c:pt>
                  <c:pt idx="1">
                    <c:v>0.0684203601158958</c:v>
                  </c:pt>
                  <c:pt idx="2">
                    <c:v>0.568626019592589</c:v>
                  </c:pt>
                  <c:pt idx="3">
                    <c:v>0.456032448934144</c:v>
                  </c:pt>
                  <c:pt idx="4">
                    <c:v>0.771093471824483</c:v>
                  </c:pt>
                  <c:pt idx="5">
                    <c:v>0.771093471824486</c:v>
                  </c:pt>
                </c:numCache>
              </c:numRef>
            </c:minus>
          </c:errBars>
          <c:cat>
            <c:strRef>
              <c:f>'Relative '!$X$63:$AB$63</c:f>
              <c:strCache>
                <c:ptCount val="5"/>
                <c:pt idx="0">
                  <c:v>X3G2</c:v>
                </c:pt>
                <c:pt idx="1">
                  <c:v>X23</c:v>
                </c:pt>
                <c:pt idx="2">
                  <c:v>X3</c:v>
                </c:pt>
                <c:pt idx="3">
                  <c:v>X2</c:v>
                </c:pt>
                <c:pt idx="4">
                  <c:v>Sum Ac</c:v>
                </c:pt>
              </c:strCache>
            </c:strRef>
          </c:cat>
          <c:val>
            <c:numRef>
              <c:f>'Relative '!$X$66:$AB$66</c:f>
              <c:numCache>
                <c:formatCode>General</c:formatCode>
                <c:ptCount val="5"/>
                <c:pt idx="0">
                  <c:v>6.66993666363949</c:v>
                </c:pt>
                <c:pt idx="1">
                  <c:v>3.26647737881154</c:v>
                </c:pt>
                <c:pt idx="2">
                  <c:v>3.382267808880256</c:v>
                </c:pt>
                <c:pt idx="3">
                  <c:v>20.4869172875487</c:v>
                </c:pt>
                <c:pt idx="4">
                  <c:v>33.80559913888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453056"/>
        <c:axId val="13455888"/>
      </c:barChart>
      <c:catAx>
        <c:axId val="134530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3455888"/>
        <c:crosses val="autoZero"/>
        <c:auto val="1"/>
        <c:lblAlgn val="ctr"/>
        <c:lblOffset val="100"/>
        <c:noMultiLvlLbl val="0"/>
      </c:catAx>
      <c:valAx>
        <c:axId val="134558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Xylopyranose units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34530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7412126730588"/>
          <c:y val="0.0588664832571028"/>
          <c:w val="0.823243723076698"/>
          <c:h val="0.7755671648389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neutral_Cal!$AC$4</c:f>
              <c:strCache>
                <c:ptCount val="1"/>
                <c:pt idx="0">
                  <c:v>WT </c:v>
                </c:pt>
              </c:strCache>
            </c:strRef>
          </c:tx>
          <c:spPr>
            <a:solidFill>
              <a:srgbClr val="5B9BD5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neutral_Cal!$AG$20:$AG$32</c:f>
                <c:numCache>
                  <c:formatCode>General</c:formatCode>
                  <c:ptCount val="13"/>
                  <c:pt idx="0">
                    <c:v>0.362709853464176</c:v>
                  </c:pt>
                  <c:pt idx="1">
                    <c:v>0.154128075286184</c:v>
                  </c:pt>
                  <c:pt idx="2">
                    <c:v>0.406349358665055</c:v>
                  </c:pt>
                  <c:pt idx="3">
                    <c:v>0.243365828574794</c:v>
                  </c:pt>
                  <c:pt idx="4">
                    <c:v>0.181167049047166</c:v>
                  </c:pt>
                  <c:pt idx="5">
                    <c:v>0.318190535406687</c:v>
                  </c:pt>
                  <c:pt idx="6">
                    <c:v>0.0337481613086062</c:v>
                  </c:pt>
                  <c:pt idx="7">
                    <c:v>0.0234944724471919</c:v>
                  </c:pt>
                  <c:pt idx="8">
                    <c:v>0.0378481629489622</c:v>
                  </c:pt>
                  <c:pt idx="9">
                    <c:v>0.0366181058562638</c:v>
                  </c:pt>
                  <c:pt idx="10">
                    <c:v>0.163722289313056</c:v>
                  </c:pt>
                  <c:pt idx="11">
                    <c:v>0.0356433620095945</c:v>
                  </c:pt>
                  <c:pt idx="12">
                    <c:v>0.0103501144149118</c:v>
                  </c:pt>
                </c:numCache>
              </c:numRef>
            </c:plus>
            <c:minus>
              <c:numRef>
                <c:f>neutral_Cal!$AG$20:$AG$32</c:f>
                <c:numCache>
                  <c:formatCode>General</c:formatCode>
                  <c:ptCount val="13"/>
                  <c:pt idx="0">
                    <c:v>0.362709853464176</c:v>
                  </c:pt>
                  <c:pt idx="1">
                    <c:v>0.154128075286184</c:v>
                  </c:pt>
                  <c:pt idx="2">
                    <c:v>0.406349358665055</c:v>
                  </c:pt>
                  <c:pt idx="3">
                    <c:v>0.243365828574794</c:v>
                  </c:pt>
                  <c:pt idx="4">
                    <c:v>0.181167049047166</c:v>
                  </c:pt>
                  <c:pt idx="5">
                    <c:v>0.318190535406687</c:v>
                  </c:pt>
                  <c:pt idx="6">
                    <c:v>0.0337481613086062</c:v>
                  </c:pt>
                  <c:pt idx="7">
                    <c:v>0.0234944724471919</c:v>
                  </c:pt>
                  <c:pt idx="8">
                    <c:v>0.0378481629489622</c:v>
                  </c:pt>
                  <c:pt idx="9">
                    <c:v>0.0366181058562638</c:v>
                  </c:pt>
                  <c:pt idx="10">
                    <c:v>0.163722289313056</c:v>
                  </c:pt>
                  <c:pt idx="11">
                    <c:v>0.0356433620095945</c:v>
                  </c:pt>
                  <c:pt idx="12">
                    <c:v>0.0103501144149118</c:v>
                  </c:pt>
                </c:numCache>
              </c:numRef>
            </c:minus>
          </c:errBars>
          <c:cat>
            <c:multiLvlStrRef>
              <c:f>neutral_Cal!$AA$5:$AB$17</c:f>
              <c:multiLvlStrCache>
                <c:ptCount val="13"/>
                <c:lvl>
                  <c:pt idx="0">
                    <c:v>Ac0</c:v>
                  </c:pt>
                  <c:pt idx="1">
                    <c:v>Ac1</c:v>
                  </c:pt>
                  <c:pt idx="2">
                    <c:v>Ac2</c:v>
                  </c:pt>
                  <c:pt idx="3">
                    <c:v>Ac1</c:v>
                  </c:pt>
                  <c:pt idx="4">
                    <c:v>Ac2</c:v>
                  </c:pt>
                  <c:pt idx="5">
                    <c:v>Ac3</c:v>
                  </c:pt>
                  <c:pt idx="6">
                    <c:v>Ac2</c:v>
                  </c:pt>
                  <c:pt idx="7">
                    <c:v>Ac3</c:v>
                  </c:pt>
                  <c:pt idx="8">
                    <c:v>Ac4</c:v>
                  </c:pt>
                  <c:pt idx="9">
                    <c:v>Ac5</c:v>
                  </c:pt>
                  <c:pt idx="10">
                    <c:v>Ac3</c:v>
                  </c:pt>
                  <c:pt idx="11">
                    <c:v>Ac4</c:v>
                  </c:pt>
                  <c:pt idx="12">
                    <c:v>Ac5</c:v>
                  </c:pt>
                </c:lvl>
                <c:lvl>
                  <c:pt idx="0">
                    <c:v>Xyl2</c:v>
                  </c:pt>
                  <c:pt idx="3">
                    <c:v>Xyl3 </c:v>
                  </c:pt>
                  <c:pt idx="6">
                    <c:v>Xyl4 </c:v>
                  </c:pt>
                  <c:pt idx="10">
                    <c:v>Xyl5 </c:v>
                  </c:pt>
                </c:lvl>
              </c:multiLvlStrCache>
            </c:multiLvlStrRef>
          </c:cat>
          <c:val>
            <c:numRef>
              <c:f>neutral_Cal!$AC$5:$AC$17</c:f>
              <c:numCache>
                <c:formatCode>General</c:formatCode>
                <c:ptCount val="13"/>
                <c:pt idx="0">
                  <c:v>3.184790180338877</c:v>
                </c:pt>
                <c:pt idx="1">
                  <c:v>41.14627921778305</c:v>
                </c:pt>
                <c:pt idx="2">
                  <c:v>17.94532032231371</c:v>
                </c:pt>
                <c:pt idx="3">
                  <c:v>8.120019630380328</c:v>
                </c:pt>
                <c:pt idx="4">
                  <c:v>9.97339824437702</c:v>
                </c:pt>
                <c:pt idx="5">
                  <c:v>8.51444856836788</c:v>
                </c:pt>
                <c:pt idx="6">
                  <c:v>1.171304116955892</c:v>
                </c:pt>
                <c:pt idx="7">
                  <c:v>4.394096244017486</c:v>
                </c:pt>
                <c:pt idx="8">
                  <c:v>3.317207235248832</c:v>
                </c:pt>
                <c:pt idx="9">
                  <c:v>0.661688354248372</c:v>
                </c:pt>
                <c:pt idx="10">
                  <c:v>0.538562168549707</c:v>
                </c:pt>
                <c:pt idx="11">
                  <c:v>0.619174764351608</c:v>
                </c:pt>
                <c:pt idx="12">
                  <c:v>0.413710953067252</c:v>
                </c:pt>
              </c:numCache>
            </c:numRef>
          </c:val>
        </c:ser>
        <c:ser>
          <c:idx val="1"/>
          <c:order val="1"/>
          <c:tx>
            <c:strRef>
              <c:f>neutral_Cal!$AD$4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rgbClr val="FF99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neutral_Cal!$AH$20:$AH$32</c:f>
                <c:numCache>
                  <c:formatCode>General</c:formatCode>
                  <c:ptCount val="13"/>
                  <c:pt idx="0">
                    <c:v>0.170751815369432</c:v>
                  </c:pt>
                  <c:pt idx="1">
                    <c:v>0.370222782538597</c:v>
                  </c:pt>
                  <c:pt idx="2">
                    <c:v>0.0823828501778063</c:v>
                  </c:pt>
                  <c:pt idx="3">
                    <c:v>0.054705784922008</c:v>
                  </c:pt>
                  <c:pt idx="4">
                    <c:v>0.318366512456279</c:v>
                  </c:pt>
                  <c:pt idx="5">
                    <c:v>0.253380646168639</c:v>
                  </c:pt>
                  <c:pt idx="6">
                    <c:v>0.0569861571033399</c:v>
                  </c:pt>
                  <c:pt idx="7">
                    <c:v>0.0874682426990327</c:v>
                  </c:pt>
                  <c:pt idx="8">
                    <c:v>0.548790142219671</c:v>
                  </c:pt>
                  <c:pt idx="9">
                    <c:v>0.0650943574260519</c:v>
                  </c:pt>
                  <c:pt idx="10">
                    <c:v>0.217552849848056</c:v>
                  </c:pt>
                  <c:pt idx="11">
                    <c:v>0.0626716106286944</c:v>
                  </c:pt>
                  <c:pt idx="12">
                    <c:v>0.0781173730437559</c:v>
                  </c:pt>
                </c:numCache>
              </c:numRef>
            </c:plus>
            <c:minus>
              <c:numRef>
                <c:f>neutral_Cal!$AH$20:$AH$32</c:f>
                <c:numCache>
                  <c:formatCode>General</c:formatCode>
                  <c:ptCount val="13"/>
                  <c:pt idx="0">
                    <c:v>0.170751815369432</c:v>
                  </c:pt>
                  <c:pt idx="1">
                    <c:v>0.370222782538597</c:v>
                  </c:pt>
                  <c:pt idx="2">
                    <c:v>0.0823828501778063</c:v>
                  </c:pt>
                  <c:pt idx="3">
                    <c:v>0.054705784922008</c:v>
                  </c:pt>
                  <c:pt idx="4">
                    <c:v>0.318366512456279</c:v>
                  </c:pt>
                  <c:pt idx="5">
                    <c:v>0.253380646168639</c:v>
                  </c:pt>
                  <c:pt idx="6">
                    <c:v>0.0569861571033399</c:v>
                  </c:pt>
                  <c:pt idx="7">
                    <c:v>0.0874682426990327</c:v>
                  </c:pt>
                  <c:pt idx="8">
                    <c:v>0.548790142219671</c:v>
                  </c:pt>
                  <c:pt idx="9">
                    <c:v>0.0650943574260519</c:v>
                  </c:pt>
                  <c:pt idx="10">
                    <c:v>0.217552849848056</c:v>
                  </c:pt>
                  <c:pt idx="11">
                    <c:v>0.0626716106286944</c:v>
                  </c:pt>
                  <c:pt idx="12">
                    <c:v>0.0781173730437559</c:v>
                  </c:pt>
                </c:numCache>
              </c:numRef>
            </c:minus>
          </c:errBars>
          <c:cat>
            <c:multiLvlStrRef>
              <c:f>neutral_Cal!$AA$5:$AB$17</c:f>
              <c:multiLvlStrCache>
                <c:ptCount val="13"/>
                <c:lvl>
                  <c:pt idx="0">
                    <c:v>Ac0</c:v>
                  </c:pt>
                  <c:pt idx="1">
                    <c:v>Ac1</c:v>
                  </c:pt>
                  <c:pt idx="2">
                    <c:v>Ac2</c:v>
                  </c:pt>
                  <c:pt idx="3">
                    <c:v>Ac1</c:v>
                  </c:pt>
                  <c:pt idx="4">
                    <c:v>Ac2</c:v>
                  </c:pt>
                  <c:pt idx="5">
                    <c:v>Ac3</c:v>
                  </c:pt>
                  <c:pt idx="6">
                    <c:v>Ac2</c:v>
                  </c:pt>
                  <c:pt idx="7">
                    <c:v>Ac3</c:v>
                  </c:pt>
                  <c:pt idx="8">
                    <c:v>Ac4</c:v>
                  </c:pt>
                  <c:pt idx="9">
                    <c:v>Ac5</c:v>
                  </c:pt>
                  <c:pt idx="10">
                    <c:v>Ac3</c:v>
                  </c:pt>
                  <c:pt idx="11">
                    <c:v>Ac4</c:v>
                  </c:pt>
                  <c:pt idx="12">
                    <c:v>Ac5</c:v>
                  </c:pt>
                </c:lvl>
                <c:lvl>
                  <c:pt idx="0">
                    <c:v>Xyl2</c:v>
                  </c:pt>
                  <c:pt idx="3">
                    <c:v>Xyl3 </c:v>
                  </c:pt>
                  <c:pt idx="6">
                    <c:v>Xyl4 </c:v>
                  </c:pt>
                  <c:pt idx="10">
                    <c:v>Xyl5 </c:v>
                  </c:pt>
                </c:lvl>
              </c:multiLvlStrCache>
            </c:multiLvlStrRef>
          </c:cat>
          <c:val>
            <c:numRef>
              <c:f>neutral_Cal!$AD$5:$AD$17</c:f>
              <c:numCache>
                <c:formatCode>General</c:formatCode>
                <c:ptCount val="13"/>
                <c:pt idx="0">
                  <c:v>4.897628445906534</c:v>
                </c:pt>
                <c:pt idx="1">
                  <c:v>39.43783177168757</c:v>
                </c:pt>
                <c:pt idx="2">
                  <c:v>17.24770509796775</c:v>
                </c:pt>
                <c:pt idx="3">
                  <c:v>7.626636836309267</c:v>
                </c:pt>
                <c:pt idx="4">
                  <c:v>11.56404654797781</c:v>
                </c:pt>
                <c:pt idx="5">
                  <c:v>7.657039766506259</c:v>
                </c:pt>
                <c:pt idx="6">
                  <c:v>1.082030789701484</c:v>
                </c:pt>
                <c:pt idx="7">
                  <c:v>5.402672776843131</c:v>
                </c:pt>
                <c:pt idx="8">
                  <c:v>3.546679792599054</c:v>
                </c:pt>
                <c:pt idx="9">
                  <c:v>0.636952013583842</c:v>
                </c:pt>
                <c:pt idx="10">
                  <c:v>0.666815814024791</c:v>
                </c:pt>
                <c:pt idx="11">
                  <c:v>0.804139599342247</c:v>
                </c:pt>
                <c:pt idx="12">
                  <c:v>0.425453876730813</c:v>
                </c:pt>
              </c:numCache>
            </c:numRef>
          </c:val>
        </c:ser>
        <c:ser>
          <c:idx val="2"/>
          <c:order val="2"/>
          <c:tx>
            <c:strRef>
              <c:f>neutral_Cal!$AE$4</c:f>
              <c:strCache>
                <c:ptCount val="1"/>
                <c:pt idx="0">
                  <c:v>17</c:v>
                </c:pt>
              </c:strCache>
            </c:strRef>
          </c:tx>
          <c:spPr>
            <a:solidFill>
              <a:srgbClr val="FFCC00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neutral_Cal!$AI$20:$AI$32</c:f>
                <c:numCache>
                  <c:formatCode>General</c:formatCode>
                  <c:ptCount val="13"/>
                  <c:pt idx="0">
                    <c:v>0.198208699957187</c:v>
                  </c:pt>
                  <c:pt idx="1">
                    <c:v>0.667737634183155</c:v>
                  </c:pt>
                  <c:pt idx="2">
                    <c:v>0.265551244005324</c:v>
                  </c:pt>
                  <c:pt idx="3">
                    <c:v>0.242499534373145</c:v>
                  </c:pt>
                  <c:pt idx="4">
                    <c:v>0.0901074117997344</c:v>
                  </c:pt>
                  <c:pt idx="5">
                    <c:v>0.259918889651132</c:v>
                  </c:pt>
                  <c:pt idx="6">
                    <c:v>0.0533762897523158</c:v>
                  </c:pt>
                  <c:pt idx="7">
                    <c:v>0.344094998382718</c:v>
                  </c:pt>
                  <c:pt idx="8">
                    <c:v>0.079904802743185</c:v>
                  </c:pt>
                  <c:pt idx="9">
                    <c:v>0.0247292423720816</c:v>
                  </c:pt>
                  <c:pt idx="10">
                    <c:v>0.0929215152062195</c:v>
                  </c:pt>
                  <c:pt idx="11">
                    <c:v>0.0239171367447967</c:v>
                  </c:pt>
                  <c:pt idx="12">
                    <c:v>0.0278817799783312</c:v>
                  </c:pt>
                </c:numCache>
              </c:numRef>
            </c:plus>
            <c:minus>
              <c:numRef>
                <c:f>neutral_Cal!$AI$20:$AI$32</c:f>
                <c:numCache>
                  <c:formatCode>General</c:formatCode>
                  <c:ptCount val="13"/>
                  <c:pt idx="0">
                    <c:v>0.198208699957187</c:v>
                  </c:pt>
                  <c:pt idx="1">
                    <c:v>0.667737634183155</c:v>
                  </c:pt>
                  <c:pt idx="2">
                    <c:v>0.265551244005324</c:v>
                  </c:pt>
                  <c:pt idx="3">
                    <c:v>0.242499534373145</c:v>
                  </c:pt>
                  <c:pt idx="4">
                    <c:v>0.0901074117997344</c:v>
                  </c:pt>
                  <c:pt idx="5">
                    <c:v>0.259918889651132</c:v>
                  </c:pt>
                  <c:pt idx="6">
                    <c:v>0.0533762897523158</c:v>
                  </c:pt>
                  <c:pt idx="7">
                    <c:v>0.344094998382718</c:v>
                  </c:pt>
                  <c:pt idx="8">
                    <c:v>0.079904802743185</c:v>
                  </c:pt>
                  <c:pt idx="9">
                    <c:v>0.0247292423720816</c:v>
                  </c:pt>
                  <c:pt idx="10">
                    <c:v>0.0929215152062195</c:v>
                  </c:pt>
                  <c:pt idx="11">
                    <c:v>0.0239171367447967</c:v>
                  </c:pt>
                  <c:pt idx="12">
                    <c:v>0.0278817799783312</c:v>
                  </c:pt>
                </c:numCache>
              </c:numRef>
            </c:minus>
          </c:errBars>
          <c:cat>
            <c:multiLvlStrRef>
              <c:f>neutral_Cal!$AA$5:$AB$17</c:f>
              <c:multiLvlStrCache>
                <c:ptCount val="13"/>
                <c:lvl>
                  <c:pt idx="0">
                    <c:v>Ac0</c:v>
                  </c:pt>
                  <c:pt idx="1">
                    <c:v>Ac1</c:v>
                  </c:pt>
                  <c:pt idx="2">
                    <c:v>Ac2</c:v>
                  </c:pt>
                  <c:pt idx="3">
                    <c:v>Ac1</c:v>
                  </c:pt>
                  <c:pt idx="4">
                    <c:v>Ac2</c:v>
                  </c:pt>
                  <c:pt idx="5">
                    <c:v>Ac3</c:v>
                  </c:pt>
                  <c:pt idx="6">
                    <c:v>Ac2</c:v>
                  </c:pt>
                  <c:pt idx="7">
                    <c:v>Ac3</c:v>
                  </c:pt>
                  <c:pt idx="8">
                    <c:v>Ac4</c:v>
                  </c:pt>
                  <c:pt idx="9">
                    <c:v>Ac5</c:v>
                  </c:pt>
                  <c:pt idx="10">
                    <c:v>Ac3</c:v>
                  </c:pt>
                  <c:pt idx="11">
                    <c:v>Ac4</c:v>
                  </c:pt>
                  <c:pt idx="12">
                    <c:v>Ac5</c:v>
                  </c:pt>
                </c:lvl>
                <c:lvl>
                  <c:pt idx="0">
                    <c:v>Xyl2</c:v>
                  </c:pt>
                  <c:pt idx="3">
                    <c:v>Xyl3 </c:v>
                  </c:pt>
                  <c:pt idx="6">
                    <c:v>Xyl4 </c:v>
                  </c:pt>
                  <c:pt idx="10">
                    <c:v>Xyl5 </c:v>
                  </c:pt>
                </c:lvl>
              </c:multiLvlStrCache>
            </c:multiLvlStrRef>
          </c:cat>
          <c:val>
            <c:numRef>
              <c:f>neutral_Cal!$AE$5:$AE$17</c:f>
              <c:numCache>
                <c:formatCode>General</c:formatCode>
                <c:ptCount val="13"/>
                <c:pt idx="0">
                  <c:v>5.313354307365497</c:v>
                </c:pt>
                <c:pt idx="1">
                  <c:v>38.68403524262932</c:v>
                </c:pt>
                <c:pt idx="2">
                  <c:v>15.91560607524695</c:v>
                </c:pt>
                <c:pt idx="3">
                  <c:v>7.874961169903692</c:v>
                </c:pt>
                <c:pt idx="4">
                  <c:v>10.97118173161443</c:v>
                </c:pt>
                <c:pt idx="5">
                  <c:v>7.88267994728486</c:v>
                </c:pt>
                <c:pt idx="6">
                  <c:v>1.457529034970482</c:v>
                </c:pt>
                <c:pt idx="7">
                  <c:v>6.019737742381743</c:v>
                </c:pt>
                <c:pt idx="8">
                  <c:v>3.2099696946371</c:v>
                </c:pt>
                <c:pt idx="9">
                  <c:v>0.636402204477601</c:v>
                </c:pt>
                <c:pt idx="10">
                  <c:v>0.71190530952814</c:v>
                </c:pt>
                <c:pt idx="11">
                  <c:v>0.885063002161015</c:v>
                </c:pt>
                <c:pt idx="12">
                  <c:v>0.43757453779917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76299680"/>
        <c:axId val="473091296"/>
      </c:barChart>
      <c:catAx>
        <c:axId val="376299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73091296"/>
        <c:crosses val="autoZero"/>
        <c:auto val="1"/>
        <c:lblAlgn val="ctr"/>
        <c:lblOffset val="100"/>
        <c:noMultiLvlLbl val="0"/>
      </c:catAx>
      <c:valAx>
        <c:axId val="4730912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ntensity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762996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6099</cdr:x>
      <cdr:y>0.49804</cdr:y>
    </cdr:from>
    <cdr:to>
      <cdr:x>0.78021</cdr:x>
      <cdr:y>0.6716</cdr:y>
    </cdr:to>
    <cdr:sp macro="" textlink="">
      <cdr:nvSpPr>
        <cdr:cNvPr id="4" name="TextBox 3"/>
        <cdr:cNvSpPr txBox="1"/>
      </cdr:nvSpPr>
      <cdr:spPr>
        <a:xfrm xmlns:a="http://schemas.openxmlformats.org/drawingml/2006/main" rot="5400000">
          <a:off x="1352976" y="1098133"/>
          <a:ext cx="363567" cy="25391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sv-S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50" dirty="0" smtClean="0">
              <a:solidFill>
                <a:srgbClr val="000000"/>
              </a:solidFill>
              <a:latin typeface="Times New Roman"/>
              <a:cs typeface="Times New Roman"/>
            </a:rPr>
            <a:t>**</a:t>
          </a:r>
          <a:endParaRPr lang="en-US" sz="1050" dirty="0">
            <a:solidFill>
              <a:srgbClr val="000000"/>
            </a:solidFill>
          </a:endParaRPr>
        </a:p>
      </cdr:txBody>
    </cdr:sp>
  </cdr:relSizeAnchor>
  <cdr:relSizeAnchor xmlns:cdr="http://schemas.openxmlformats.org/drawingml/2006/chartDrawing">
    <cdr:from>
      <cdr:x>0.80038</cdr:x>
      <cdr:y>0.29713</cdr:y>
    </cdr:from>
    <cdr:to>
      <cdr:x>0.92321</cdr:x>
      <cdr:y>0.5</cdr:y>
    </cdr:to>
    <cdr:sp macro="" textlink="">
      <cdr:nvSpPr>
        <cdr:cNvPr id="5" name="TextBox 4"/>
        <cdr:cNvSpPr txBox="1"/>
      </cdr:nvSpPr>
      <cdr:spPr>
        <a:xfrm xmlns:a="http://schemas.openxmlformats.org/drawingml/2006/main" rot="5400000">
          <a:off x="1622997" y="704117"/>
          <a:ext cx="424974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sv-S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50" dirty="0" smtClean="0">
              <a:solidFill>
                <a:srgbClr val="000000"/>
              </a:solidFill>
              <a:latin typeface="Times New Roman"/>
              <a:cs typeface="Times New Roman"/>
            </a:rPr>
            <a:t>**</a:t>
          </a:r>
          <a:endParaRPr lang="en-US" sz="1050" dirty="0">
            <a:solidFill>
              <a:srgbClr val="000000"/>
            </a:solidFill>
          </a:endParaRPr>
        </a:p>
      </cdr:txBody>
    </cdr:sp>
  </cdr:relSizeAnchor>
  <cdr:relSizeAnchor xmlns:cdr="http://schemas.openxmlformats.org/drawingml/2006/chartDrawing">
    <cdr:from>
      <cdr:x>0.69217</cdr:x>
      <cdr:y>0.5</cdr:y>
    </cdr:from>
    <cdr:to>
      <cdr:x>0.81139</cdr:x>
      <cdr:y>0.63523</cdr:y>
    </cdr:to>
    <cdr:sp macro="" textlink="">
      <cdr:nvSpPr>
        <cdr:cNvPr id="6" name="TextBox 5"/>
        <cdr:cNvSpPr txBox="1"/>
      </cdr:nvSpPr>
      <cdr:spPr>
        <a:xfrm xmlns:a="http://schemas.openxmlformats.org/drawingml/2006/main" rot="5400000">
          <a:off x="1459530" y="1062092"/>
          <a:ext cx="283282" cy="25391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sv-S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050" dirty="0" smtClean="0">
              <a:solidFill>
                <a:srgbClr val="000000"/>
              </a:solidFill>
              <a:latin typeface="Times New Roman"/>
              <a:cs typeface="Times New Roman"/>
            </a:rPr>
            <a:t>*</a:t>
          </a:r>
          <a:endParaRPr lang="en-US" sz="1050" dirty="0">
            <a:solidFill>
              <a:srgbClr val="000000"/>
            </a:solidFill>
          </a:endParaRPr>
        </a:p>
      </cdr:txBody>
    </cdr:sp>
  </cdr:relSizeAnchor>
  <cdr:relSizeAnchor xmlns:cdr="http://schemas.openxmlformats.org/drawingml/2006/chartDrawing">
    <cdr:from>
      <cdr:x>0.62961</cdr:x>
      <cdr:y>0.33987</cdr:y>
    </cdr:from>
    <cdr:to>
      <cdr:x>0.76782</cdr:x>
      <cdr:y>0.33987</cdr:y>
    </cdr:to>
    <cdr:cxnSp macro="">
      <cdr:nvCxnSpPr>
        <cdr:cNvPr id="7" name="Straight Connector 6"/>
        <cdr:cNvCxnSpPr/>
      </cdr:nvCxnSpPr>
      <cdr:spPr>
        <a:xfrm xmlns:a="http://schemas.openxmlformats.org/drawingml/2006/main">
          <a:off x="1340969" y="711966"/>
          <a:ext cx="294358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4639</cdr:x>
      <cdr:y>0.11474</cdr:y>
    </cdr:from>
    <cdr:to>
      <cdr:x>0.92536</cdr:x>
      <cdr:y>0.11717</cdr:y>
    </cdr:to>
    <cdr:cxnSp macro="">
      <cdr:nvCxnSpPr>
        <cdr:cNvPr id="8" name="Straight Connector 7"/>
        <cdr:cNvCxnSpPr/>
      </cdr:nvCxnSpPr>
      <cdr:spPr>
        <a:xfrm xmlns:a="http://schemas.openxmlformats.org/drawingml/2006/main">
          <a:off x="1589686" y="240366"/>
          <a:ext cx="381180" cy="5086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1069</cdr:x>
      <cdr:y>0.24163</cdr:y>
    </cdr:from>
    <cdr:to>
      <cdr:x>0.8485</cdr:x>
      <cdr:y>0.34448</cdr:y>
    </cdr:to>
    <cdr:sp macro="" textlink="">
      <cdr:nvSpPr>
        <cdr:cNvPr id="9" name="TextBox 8"/>
        <cdr:cNvSpPr txBox="1"/>
      </cdr:nvSpPr>
      <cdr:spPr>
        <a:xfrm xmlns:a="http://schemas.openxmlformats.org/drawingml/2006/main">
          <a:off x="1087686" y="506181"/>
          <a:ext cx="719478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sv-S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800" i="1" dirty="0" smtClean="0">
              <a:latin typeface="Helvetica" panose="020B0604020202020204" pitchFamily="34" charset="0"/>
              <a:cs typeface="Helvetica" panose="020B0604020202020204" pitchFamily="34" charset="0"/>
            </a:rPr>
            <a:t>P</a:t>
          </a:r>
          <a:r>
            <a:rPr lang="sv-SE" sz="800" dirty="0" smtClean="0">
              <a:latin typeface="Helvetica" panose="020B0604020202020204" pitchFamily="34" charset="0"/>
              <a:cs typeface="Helvetica" panose="020B0604020202020204" pitchFamily="34" charset="0"/>
            </a:rPr>
            <a:t> ≤ 0.002</a:t>
          </a:r>
          <a:endParaRPr lang="en-US" sz="800" dirty="0">
            <a:latin typeface="Helvetica" panose="020B0604020202020204" pitchFamily="34" charset="0"/>
            <a:cs typeface="Helvetica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8719</cdr:x>
      <cdr:y>0.03254</cdr:y>
    </cdr:from>
    <cdr:to>
      <cdr:x>1</cdr:x>
      <cdr:y>0.13539</cdr:y>
    </cdr:to>
    <cdr:sp macro="" textlink="">
      <cdr:nvSpPr>
        <cdr:cNvPr id="10" name="TextBox 9"/>
        <cdr:cNvSpPr txBox="1"/>
      </cdr:nvSpPr>
      <cdr:spPr>
        <a:xfrm xmlns:a="http://schemas.openxmlformats.org/drawingml/2006/main">
          <a:off x="1463587" y="68172"/>
          <a:ext cx="666242" cy="21544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sv-SE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sv-SE" sz="800" i="1" dirty="0" smtClean="0">
              <a:latin typeface="Helvetica" panose="020B0604020202020204" pitchFamily="34" charset="0"/>
              <a:cs typeface="Helvetica" panose="020B0604020202020204" pitchFamily="34" charset="0"/>
            </a:rPr>
            <a:t>P</a:t>
          </a:r>
          <a:r>
            <a:rPr lang="sv-SE" sz="800" dirty="0" smtClean="0">
              <a:latin typeface="Helvetica" panose="020B0604020202020204" pitchFamily="34" charset="0"/>
              <a:cs typeface="Helvetica" panose="020B0604020202020204" pitchFamily="34" charset="0"/>
            </a:rPr>
            <a:t> ≤ 0.04</a:t>
          </a:r>
          <a:endParaRPr lang="en-US" sz="800" dirty="0">
            <a:latin typeface="Helvetica" panose="020B0604020202020204" pitchFamily="34" charset="0"/>
            <a:cs typeface="Helvetica" panose="020B0604020202020204" pitchFamily="34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901" y="0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/>
          <a:lstStyle>
            <a:lvl1pPr algn="r">
              <a:defRPr sz="1200"/>
            </a:lvl1pPr>
          </a:lstStyle>
          <a:p>
            <a:fld id="{2FF1960E-E555-4FA3-9B89-F6C507E6E2AA}" type="datetimeFigureOut">
              <a:rPr lang="sv-SE" smtClean="0"/>
              <a:t>2017-02-27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" y="9430223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901" y="9430223"/>
            <a:ext cx="2946189" cy="496411"/>
          </a:xfrm>
          <a:prstGeom prst="rect">
            <a:avLst/>
          </a:prstGeom>
        </p:spPr>
        <p:txBody>
          <a:bodyPr vert="horz" lIns="91557" tIns="45781" rIns="91557" bIns="45781" rtlCol="0" anchor="b"/>
          <a:lstStyle>
            <a:lvl1pPr algn="r">
              <a:defRPr sz="1200"/>
            </a:lvl1pPr>
          </a:lstStyle>
          <a:p>
            <a:fld id="{7C1B93AD-520F-4581-BE6F-51B87980073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209924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99" y="0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/>
          <a:lstStyle>
            <a:lvl1pPr algn="r">
              <a:defRPr sz="1200"/>
            </a:lvl1pPr>
          </a:lstStyle>
          <a:p>
            <a:fld id="{E4AFCDE8-A4CE-4EFF-90A2-ECD6F20BC010}" type="datetimeFigureOut">
              <a:rPr lang="sv-SE" smtClean="0"/>
              <a:t>2017-02-27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33575" y="744538"/>
            <a:ext cx="2930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77" tIns="45789" rIns="91577" bIns="45789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577" tIns="45789" rIns="91577" bIns="457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23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99" y="9430223"/>
            <a:ext cx="2946189" cy="496411"/>
          </a:xfrm>
          <a:prstGeom prst="rect">
            <a:avLst/>
          </a:prstGeom>
        </p:spPr>
        <p:txBody>
          <a:bodyPr vert="horz" lIns="91577" tIns="45789" rIns="91577" bIns="45789" rtlCol="0" anchor="b"/>
          <a:lstStyle>
            <a:lvl1pPr algn="r">
              <a:defRPr sz="1200"/>
            </a:lvl1pPr>
          </a:lstStyle>
          <a:p>
            <a:fld id="{745306A8-4DFD-4413-A84A-BFC106AD664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162331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0069" y="2840569"/>
            <a:ext cx="6120765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0135" y="5181600"/>
            <a:ext cx="504063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036F4-A069-4F11-BE7E-7A3C4C4E2882}" type="datetime1">
              <a:rPr lang="sv-SE" smtClean="0"/>
              <a:t>2017-02-2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89913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CA7EC7-A8ED-4E57-AD02-F8627BD99325}" type="datetime1">
              <a:rPr lang="sv-SE" smtClean="0"/>
              <a:t>2017-02-2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18630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20652" y="366187"/>
            <a:ext cx="1620203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0046" y="366187"/>
            <a:ext cx="4740593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C765F9-6B29-4AF2-A37B-05089206B78B}" type="datetime1">
              <a:rPr lang="sv-SE" smtClean="0"/>
              <a:t>2017-02-2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89420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C4E50-9D58-40CD-86C2-165D68EDC912}" type="datetime1">
              <a:rPr lang="sv-SE" smtClean="0"/>
              <a:t>2017-02-2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4518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823" y="5875867"/>
            <a:ext cx="6120765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823" y="3875621"/>
            <a:ext cx="6120765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DA7F7-A8EC-4B47-93E2-EA186C502563}" type="datetime1">
              <a:rPr lang="sv-SE" smtClean="0"/>
              <a:t>2017-02-2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55044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0045" y="2133604"/>
            <a:ext cx="3180398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60457" y="2133604"/>
            <a:ext cx="3180398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2059E-B7C7-4ADE-BAE4-D3E07BAA057E}" type="datetime1">
              <a:rPr lang="sv-SE" smtClean="0"/>
              <a:t>2017-02-2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37766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047" y="2046817"/>
            <a:ext cx="3181648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0047" y="2899833"/>
            <a:ext cx="3181648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7959" y="2046817"/>
            <a:ext cx="3182898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7959" y="2899833"/>
            <a:ext cx="3182898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D9705-B01C-46C3-BA33-48D1DA937F7E}" type="datetime1">
              <a:rPr lang="sv-SE" smtClean="0"/>
              <a:t>2017-02-27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19655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56B54-9DF1-4CA6-9C22-F861898EF72C}" type="datetime1">
              <a:rPr lang="sv-SE" smtClean="0"/>
              <a:t>2017-02-27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90526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1439F4-3F18-4A1A-B292-BB63CADEFD07}" type="datetime1">
              <a:rPr lang="sv-SE" smtClean="0"/>
              <a:t>2017-02-27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3794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0046" y="364067"/>
            <a:ext cx="2369047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5353" y="364070"/>
            <a:ext cx="4025504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0046" y="1913470"/>
            <a:ext cx="2369047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986FE4-47C4-4A27-B682-7CC63600B5A7}" type="datetime1">
              <a:rPr lang="sv-SE" smtClean="0"/>
              <a:t>2017-02-2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1491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1427" y="6400803"/>
            <a:ext cx="432054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1427" y="817033"/>
            <a:ext cx="432054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1427" y="7156454"/>
            <a:ext cx="432054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5B887-CE02-4C8D-95DA-1259335DE4B0}" type="datetime1">
              <a:rPr lang="sv-SE" smtClean="0"/>
              <a:t>2017-02-2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056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0045" y="366184"/>
            <a:ext cx="648081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0045" y="2133604"/>
            <a:ext cx="648081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0045" y="8475137"/>
            <a:ext cx="168021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B854E-4C3B-470B-AFE8-A93947DE2736}" type="datetime1">
              <a:rPr lang="sv-SE" smtClean="0"/>
              <a:t>2017-02-2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60309" y="8475137"/>
            <a:ext cx="22802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0645" y="8475137"/>
            <a:ext cx="168021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9E9F1-820E-4EB4-BD74-329B6C2459E2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47521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0" y="6107395"/>
            <a:ext cx="72009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dditional file 2. Transgenic lines expressing AnAxE1 have reduced acetylation of </a:t>
            </a:r>
            <a:r>
              <a:rPr lang="en-US" sz="1000" b="1" dirty="0" err="1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xylan</a:t>
            </a:r>
            <a:r>
              <a:rPr lang="en-US" sz="10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. A. </a:t>
            </a:r>
            <a:r>
              <a:rPr lang="sv-SE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OLIMP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nalysis of 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neutral </a:t>
            </a:r>
            <a:r>
              <a:rPr lang="en-US" sz="1000" dirty="0" err="1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xylo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oligosaccharides (XOS) released by </a:t>
            </a:r>
            <a:r>
              <a:rPr lang="en-US" sz="1000" dirty="0" err="1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ndoxylanase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The 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XOS ranged from DP 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2 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to 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5 (Xyl2 – Xyl5) 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nd had 0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5 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cetyl groups (Ac0 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– Ac5)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Means ± </a:t>
            </a:r>
            <a:r>
              <a:rPr lang="en-US" sz="1000" i="1" dirty="0" smtClean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E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, </a:t>
            </a:r>
            <a:r>
              <a:rPr lang="en-US" sz="1000" i="1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n 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= 2 biol. replicates representing pools of 5 individual trees. </a:t>
            </a:r>
            <a:r>
              <a:rPr lang="en-US" sz="1000" b="1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NMR analysis of </a:t>
            </a:r>
            <a:r>
              <a:rPr lang="en-US" sz="1000" dirty="0" err="1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xylan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acetylation using 2D </a:t>
            </a:r>
            <a:r>
              <a:rPr lang="en-US" sz="1000" dirty="0" err="1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qHSQC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spectra. The numbers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after X refer to the positions of acetyl groups i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xylopyranosyl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Xyl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) units; G2 refers to (Me)-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glucuronosyl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substitution at position 2 of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Xyl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. All signals from H1/C1 vibration in </a:t>
            </a:r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Xyl</a:t>
            </a:r>
            <a:r>
              <a:rPr lang="en-US" sz="10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are considered are 100% and % of each unit type is calculated. X3, X2 and X23 are normalized with H3C3 and H2C2 signals. Sum Ac is a sum of all acetylated </a:t>
            </a:r>
            <a:r>
              <a:rPr lang="en-US" sz="1000" dirty="0" err="1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Xyl</a:t>
            </a:r>
            <a:r>
              <a:rPr lang="en-US" sz="1000" i="1" dirty="0" err="1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units. 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Data are means 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± SE, </a:t>
            </a:r>
            <a:r>
              <a:rPr lang="en-US" sz="1000" i="1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n</a:t>
            </a:r>
            <a:r>
              <a:rPr lang="en-US" sz="1000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= 3-5 biological replicates</a:t>
            </a:r>
            <a:r>
              <a:rPr lang="en-US" sz="1000" b="1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.</a:t>
            </a:r>
            <a:r>
              <a:rPr lang="en-US" sz="1000" dirty="0" smtClean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In A and B, a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terisks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represent lines significantly different from WT: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*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-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P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≤ 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0.1; *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* -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P 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≤ 0.05; *** - </a:t>
            </a:r>
            <a:r>
              <a:rPr lang="en-US" sz="1000" i="1" dirty="0">
                <a:latin typeface="Helvetica" panose="020B0604020202020204" pitchFamily="34" charset="0"/>
                <a:cs typeface="Helvetica" panose="020B0604020202020204" pitchFamily="34" charset="0"/>
              </a:rPr>
              <a:t>P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≤ 0.01 (Student’s t-test</a:t>
            </a:r>
            <a:r>
              <a:rPr lang="en-US" sz="1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). P values above the bars represent the post-ANOVA contrast between the both transgenic lines and WT.</a:t>
            </a:r>
            <a:endParaRPr lang="en-US" sz="1000" dirty="0"/>
          </a:p>
        </p:txBody>
      </p:sp>
      <p:grpSp>
        <p:nvGrpSpPr>
          <p:cNvPr id="2" name="Group 1"/>
          <p:cNvGrpSpPr/>
          <p:nvPr/>
        </p:nvGrpSpPr>
        <p:grpSpPr>
          <a:xfrm>
            <a:off x="1202585" y="2922732"/>
            <a:ext cx="3416066" cy="2400860"/>
            <a:chOff x="1202585" y="2922732"/>
            <a:chExt cx="3416066" cy="2400860"/>
          </a:xfrm>
        </p:grpSpPr>
        <p:sp>
          <p:nvSpPr>
            <p:cNvPr id="6" name="TextBox 5"/>
            <p:cNvSpPr txBox="1"/>
            <p:nvPr/>
          </p:nvSpPr>
          <p:spPr>
            <a:xfrm rot="5400000">
              <a:off x="1165567" y="4696885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7" name="TextBox 6"/>
            <p:cNvSpPr txBox="1"/>
            <p:nvPr/>
          </p:nvSpPr>
          <p:spPr>
            <a:xfrm rot="5400000">
              <a:off x="1090660" y="4711056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8" name="TextBox 7"/>
            <p:cNvSpPr txBox="1"/>
            <p:nvPr/>
          </p:nvSpPr>
          <p:spPr>
            <a:xfrm rot="5400000">
              <a:off x="1435846" y="3034657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9" name="TextBox 8"/>
            <p:cNvSpPr txBox="1"/>
            <p:nvPr/>
          </p:nvSpPr>
          <p:spPr>
            <a:xfrm rot="5400000">
              <a:off x="1371425" y="3120319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</a:t>
              </a:r>
              <a:endParaRPr lang="en-US" sz="1400" dirty="0"/>
            </a:p>
          </p:txBody>
        </p:sp>
        <p:sp>
          <p:nvSpPr>
            <p:cNvPr id="10" name="TextBox 9"/>
            <p:cNvSpPr txBox="1"/>
            <p:nvPr/>
          </p:nvSpPr>
          <p:spPr>
            <a:xfrm rot="5400000">
              <a:off x="1711205" y="4165293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11" name="TextBox 10"/>
            <p:cNvSpPr txBox="1"/>
            <p:nvPr/>
          </p:nvSpPr>
          <p:spPr>
            <a:xfrm rot="5400000">
              <a:off x="2195218" y="4370858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12" name="TextBox 11"/>
            <p:cNvSpPr txBox="1"/>
            <p:nvPr/>
          </p:nvSpPr>
          <p:spPr>
            <a:xfrm rot="5400000">
              <a:off x="2273187" y="4416928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13" name="TextBox 12"/>
            <p:cNvSpPr txBox="1"/>
            <p:nvPr/>
          </p:nvSpPr>
          <p:spPr>
            <a:xfrm rot="5400000">
              <a:off x="2600715" y="4500199"/>
              <a:ext cx="39337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5400000">
              <a:off x="3086072" y="4641621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 rot="5400000">
              <a:off x="3015179" y="4708957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5400000">
              <a:off x="4198949" y="4903889"/>
              <a:ext cx="53162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*</a:t>
              </a:r>
              <a:endParaRPr lang="en-US" sz="14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5400000">
              <a:off x="4260962" y="4859585"/>
              <a:ext cx="2658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*</a:t>
              </a:r>
              <a:endParaRPr lang="en-US" sz="1400" dirty="0"/>
            </a:p>
          </p:txBody>
        </p:sp>
      </p:grpSp>
      <p:graphicFrame>
        <p:nvGraphicFramePr>
          <p:cNvPr id="19" name="Chart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96460785"/>
              </p:ext>
            </p:extLst>
          </p:nvPr>
        </p:nvGraphicFramePr>
        <p:xfrm>
          <a:off x="4795054" y="3477336"/>
          <a:ext cx="2129829" cy="20948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5028393" y="2693625"/>
            <a:ext cx="526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sv-SE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91151" y="2630408"/>
            <a:ext cx="5263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sv-SE" sz="12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4273021" y="3047279"/>
            <a:ext cx="1151277" cy="215444"/>
            <a:chOff x="5130818" y="3308109"/>
            <a:chExt cx="1151277" cy="215444"/>
          </a:xfrm>
        </p:grpSpPr>
        <p:sp>
          <p:nvSpPr>
            <p:cNvPr id="25" name="TextBox 24"/>
            <p:cNvSpPr txBox="1"/>
            <p:nvPr/>
          </p:nvSpPr>
          <p:spPr>
            <a:xfrm>
              <a:off x="5130818" y="3308109"/>
              <a:ext cx="11512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Helvetica" charset="0"/>
                  <a:ea typeface="Helvetica" charset="0"/>
                  <a:cs typeface="Helvetica" charset="0"/>
                </a:rPr>
                <a:t>WT          4            17</a:t>
              </a:r>
              <a:endParaRPr lang="en-US" sz="8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5383032" y="3378530"/>
              <a:ext cx="73679" cy="75830"/>
            </a:xfrm>
            <a:prstGeom prst="rect">
              <a:avLst/>
            </a:prstGeom>
            <a:solidFill>
              <a:srgbClr val="5B9BD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5750661" y="3378530"/>
              <a:ext cx="73679" cy="75830"/>
            </a:xfrm>
            <a:prstGeom prst="rect">
              <a:avLst/>
            </a:prstGeom>
            <a:solidFill>
              <a:srgbClr val="FFC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6192551" y="3378530"/>
              <a:ext cx="73679" cy="75830"/>
            </a:xfrm>
            <a:prstGeom prst="rect">
              <a:avLst/>
            </a:prstGeom>
            <a:solidFill>
              <a:srgbClr val="FF99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5836469"/>
              </p:ext>
            </p:extLst>
          </p:nvPr>
        </p:nvGraphicFramePr>
        <p:xfrm>
          <a:off x="702912" y="2814321"/>
          <a:ext cx="4375392" cy="2822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472920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437</TotalTime>
  <Words>250</Words>
  <Application>Microsoft Macintosh PowerPoint</Application>
  <PresentationFormat>Custom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Helvetica</vt:lpstr>
      <vt:lpstr>Times New Roman</vt:lpstr>
      <vt:lpstr>Arial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5.003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 Ratke</dc:creator>
  <cp:lastModifiedBy>Ewa</cp:lastModifiedBy>
  <cp:revision>984</cp:revision>
  <cp:lastPrinted>2014-10-29T14:52:00Z</cp:lastPrinted>
  <dcterms:created xsi:type="dcterms:W3CDTF">2012-08-30T12:05:59Z</dcterms:created>
  <dcterms:modified xsi:type="dcterms:W3CDTF">2017-02-27T10:50:32Z</dcterms:modified>
</cp:coreProperties>
</file>